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86575" cy="96234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A973CC-C8CE-434B-B5F6-150047799EE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7DFA0F-D6D0-4AE9-B8B8-760C7C3DF34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11D7FB-1DDD-49A2-BC55-F14B6285022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C355F5-3A53-4083-A31F-B83C9CEF7A4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94A6AC-5E55-4C21-9B0C-1E034E3F29B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A00CEB-3B24-4D8E-9252-AA1F81407CA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41B813-AA63-46FC-8235-45B2F0D2A65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AA56F7-F9F5-41BC-988C-708A83B205F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ACD6AB-F32C-4359-B59C-A4299712123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EADB80-45D4-4B1E-B953-A6BADFDA4A2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EDC486-C939-45B6-85E1-D5462625F1B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DAD3A4-F650-429A-983A-06E67D6A792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  <a:ea typeface="ＭＳ Ｐゴシック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7F6BABE-F891-4B9F-8B8E-DABC3B7DC76B}" type="slidenum">
              <a:rPr b="0" lang="en-US" sz="14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Gadget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2"/>
          <p:cNvSpPr/>
          <p:nvPr/>
        </p:nvSpPr>
        <p:spPr>
          <a:xfrm>
            <a:off x="784080" y="5046840"/>
            <a:ext cx="184320" cy="579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2" name="Text Box 3"/>
          <p:cNvSpPr/>
          <p:nvPr/>
        </p:nvSpPr>
        <p:spPr>
          <a:xfrm>
            <a:off x="32731200" y="8393040"/>
            <a:ext cx="5805360" cy="2099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1160"/>
                <a:tab algn="l" pos="1822320"/>
                <a:tab algn="l" pos="2733840"/>
                <a:tab algn="l" pos="3645000"/>
                <a:tab algn="l" pos="4556160"/>
                <a:tab algn="l" pos="5467320"/>
                <a:tab algn="l" pos="6378480"/>
                <a:tab algn="l" pos="7289640"/>
                <a:tab algn="l" pos="8201160"/>
                <a:tab algn="l" pos="9112320"/>
                <a:tab algn="l" pos="10023480"/>
                <a:tab algn="l" pos="1093464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Fig. 4. Geographic distribution of tested 18 populations of wild emmer wheat at 15 sites in Israel.  The populations numbered 1-5 were collected from, warm, humid environments on the Golan Plateau and near the Sea of Galilee (Yehudiyya, Gamla, Ammaid, Rosh-Pinna, Tabigha).</a:t>
            </a:r>
            <a:endParaRPr b="0" lang="en-US" sz="1200" spc="-1" strike="noStrike">
              <a:solidFill>
                <a:srgbClr val="000000"/>
              </a:solidFill>
              <a:latin typeface="Gadget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1160"/>
                <a:tab algn="l" pos="1822320"/>
                <a:tab algn="l" pos="2733840"/>
                <a:tab algn="l" pos="3645000"/>
                <a:tab algn="l" pos="4556160"/>
                <a:tab algn="l" pos="5467320"/>
                <a:tab algn="l" pos="6378480"/>
                <a:tab algn="l" pos="7289640"/>
                <a:tab algn="l" pos="8201160"/>
                <a:tab algn="l" pos="9112320"/>
                <a:tab algn="l" pos="10023480"/>
                <a:tab algn="l" pos="1093464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The populations numbered 6-11 were collected across a wide geographic and marginal steppic area on northern, eastern, and southern borders of wild emmer distribution, involving hot, cold and xeric peripheries (Mt. Hermon, Mt. Gilboa, Mt. Gerizim, Gitit, Kokhav-Hashahar, J’aba).</a:t>
            </a:r>
            <a:endParaRPr b="0" lang="en-US" sz="1200" spc="-1" strike="noStrike">
              <a:solidFill>
                <a:srgbClr val="000000"/>
              </a:solidFill>
              <a:latin typeface="Gadget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1160"/>
                <a:tab algn="l" pos="1822320"/>
                <a:tab algn="l" pos="2733840"/>
                <a:tab algn="l" pos="3645000"/>
                <a:tab algn="l" pos="4556160"/>
                <a:tab algn="l" pos="5467320"/>
                <a:tab algn="l" pos="6378480"/>
                <a:tab algn="l" pos="7289640"/>
                <a:tab algn="l" pos="8201160"/>
                <a:tab algn="l" pos="9112320"/>
                <a:tab algn="l" pos="10023480"/>
                <a:tab algn="l" pos="1093464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The populations numbered 12-15 were collected from Marginal Mediterranean areas, which are the western borders of wild emmer distribution (Amirim, Beit-Oren, Bat-Shelomo, Givat-Koach).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3" name="Text Box 4"/>
          <p:cNvSpPr/>
          <p:nvPr/>
        </p:nvSpPr>
        <p:spPr>
          <a:xfrm>
            <a:off x="200160" y="5495760"/>
            <a:ext cx="894384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dditional file 3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Geographic distribution of 18 tested populations of wild emmer wheat at 15 sites in Israel. 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opulations 1-6 were collected from warm, semi-humid environments on the Golan Plateau and near the Sea of Galilee (Yehudiyya, Gamla, Ammiad, Rosh-Pinna, Tabigha, and Mt. Hermon). Populations 7-11 were collected across a wide geographic and marginal steppic area on northern, eastern, and southern borders of wild emmer distribution involving hot, cold, and xeric peripheries (Mt. Gilboa, Mt. Gerizim, Gitit, Kokhav-Hashahar, and J’aba). Populations 12-15 were collected from marginal Mediterranean areas, which are the humid western borders of wild emmer distribution (Amirim, Bet Oren, Bat Shelomo, and Giv’at Koah).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4" name="Text Box 5"/>
          <p:cNvSpPr/>
          <p:nvPr/>
        </p:nvSpPr>
        <p:spPr>
          <a:xfrm>
            <a:off x="6638760" y="1012680"/>
            <a:ext cx="1572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Catchment area</a:t>
            </a:r>
            <a:endParaRPr b="0" lang="en-US" sz="16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5" name="Text Box 6"/>
          <p:cNvSpPr/>
          <p:nvPr/>
        </p:nvSpPr>
        <p:spPr>
          <a:xfrm>
            <a:off x="6676200" y="3008160"/>
            <a:ext cx="2087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Marginal steppic area</a:t>
            </a:r>
            <a:endParaRPr b="0" lang="en-US" sz="16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6" name="Text Box 7"/>
          <p:cNvSpPr/>
          <p:nvPr/>
        </p:nvSpPr>
        <p:spPr>
          <a:xfrm>
            <a:off x="6694920" y="4624560"/>
            <a:ext cx="1963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Marginal mesic area</a:t>
            </a:r>
            <a:endParaRPr b="0" lang="en-US" sz="16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7" name="Text Box 9"/>
          <p:cNvSpPr/>
          <p:nvPr/>
        </p:nvSpPr>
        <p:spPr>
          <a:xfrm>
            <a:off x="4519440" y="0"/>
            <a:ext cx="2146680" cy="55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1.Yehudiyya</a:t>
            </a:r>
            <a:endParaRPr b="0" lang="en-US" sz="2400" spc="-1" strike="noStrike">
              <a:solidFill>
                <a:srgbClr val="000000"/>
              </a:solidFill>
              <a:latin typeface="Gadget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2.Gamla</a:t>
            </a:r>
            <a:endParaRPr b="0" lang="en-US" sz="2400" spc="-1" strike="noStrike">
              <a:solidFill>
                <a:srgbClr val="000000"/>
              </a:solidFill>
              <a:latin typeface="Gadget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3.Rosh-Pinna</a:t>
            </a:r>
            <a:endParaRPr b="0" lang="en-US" sz="2400" spc="-1" strike="noStrike">
              <a:solidFill>
                <a:srgbClr val="000000"/>
              </a:solidFill>
              <a:latin typeface="Gadget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4.Ammiad</a:t>
            </a:r>
            <a:endParaRPr b="0" lang="en-US" sz="2400" spc="-1" strike="noStrike">
              <a:solidFill>
                <a:srgbClr val="000000"/>
              </a:solidFill>
              <a:latin typeface="Gadget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5.Tabigha</a:t>
            </a:r>
            <a:endParaRPr b="0" lang="en-US" sz="2400" spc="-1" strike="noStrike">
              <a:solidFill>
                <a:srgbClr val="000000"/>
              </a:solidFill>
              <a:latin typeface="Gadget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6.Mt.Hermon</a:t>
            </a:r>
            <a:endParaRPr b="0" lang="en-US" sz="2400" spc="-1" strike="noStrike">
              <a:solidFill>
                <a:srgbClr val="000000"/>
              </a:solidFill>
              <a:latin typeface="Gadget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ff"/>
                </a:solidFill>
                <a:latin typeface="Times New Roman"/>
                <a:ea typeface="ＭＳ Ｐゴシック"/>
              </a:rPr>
              <a:t>7.Mt.Gilboa</a:t>
            </a:r>
            <a:endParaRPr b="0" lang="en-US" sz="2400" spc="-1" strike="noStrike">
              <a:solidFill>
                <a:srgbClr val="000000"/>
              </a:solidFill>
              <a:latin typeface="Gadget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ff"/>
                </a:solidFill>
                <a:latin typeface="Times New Roman"/>
                <a:ea typeface="ＭＳ Ｐゴシック"/>
              </a:rPr>
              <a:t>8.Mt.Gerizim</a:t>
            </a:r>
            <a:endParaRPr b="0" lang="en-US" sz="2400" spc="-1" strike="noStrike">
              <a:solidFill>
                <a:srgbClr val="000000"/>
              </a:solidFill>
              <a:latin typeface="Gadget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ff"/>
                </a:solidFill>
                <a:latin typeface="Times New Roman"/>
                <a:ea typeface="ＭＳ Ｐゴシック"/>
              </a:rPr>
              <a:t>9.Gitit</a:t>
            </a:r>
            <a:endParaRPr b="0" lang="en-US" sz="2400" spc="-1" strike="noStrike">
              <a:solidFill>
                <a:srgbClr val="000000"/>
              </a:solidFill>
              <a:latin typeface="Gadget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ff"/>
                </a:solidFill>
                <a:latin typeface="Times New Roman"/>
                <a:ea typeface="ＭＳ Ｐゴシック"/>
              </a:rPr>
              <a:t>10.Kokhav</a:t>
            </a:r>
            <a:endParaRPr b="0" lang="en-US" sz="2400" spc="-1" strike="noStrike">
              <a:solidFill>
                <a:srgbClr val="000000"/>
              </a:solidFill>
              <a:latin typeface="Gadget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ff"/>
                </a:solidFill>
                <a:latin typeface="Times New Roman"/>
                <a:ea typeface="ＭＳ Ｐゴシック"/>
              </a:rPr>
              <a:t>11.J’aba</a:t>
            </a:r>
            <a:endParaRPr b="0" lang="en-US" sz="2400" spc="-1" strike="noStrike">
              <a:solidFill>
                <a:srgbClr val="000000"/>
              </a:solidFill>
              <a:latin typeface="Gadget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0000"/>
                </a:solidFill>
                <a:latin typeface="Times New Roman"/>
                <a:ea typeface="ＭＳ Ｐゴシック"/>
              </a:rPr>
              <a:t>12.Amirim</a:t>
            </a:r>
            <a:endParaRPr b="0" lang="en-US" sz="2400" spc="-1" strike="noStrike">
              <a:solidFill>
                <a:srgbClr val="000000"/>
              </a:solidFill>
              <a:latin typeface="Gadget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0000"/>
                </a:solidFill>
                <a:latin typeface="Times New Roman"/>
                <a:ea typeface="ＭＳ Ｐゴシック"/>
              </a:rPr>
              <a:t>13.Bet Oren</a:t>
            </a:r>
            <a:endParaRPr b="0" lang="en-US" sz="2400" spc="-1" strike="noStrike">
              <a:solidFill>
                <a:srgbClr val="000000"/>
              </a:solidFill>
              <a:latin typeface="Gadget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0000"/>
                </a:solidFill>
                <a:latin typeface="Times New Roman"/>
                <a:ea typeface="ＭＳ Ｐゴシック"/>
              </a:rPr>
              <a:t>14.Bat Shelomo</a:t>
            </a:r>
            <a:endParaRPr b="0" lang="en-US" sz="2400" spc="-1" strike="noStrike">
              <a:solidFill>
                <a:srgbClr val="000000"/>
              </a:solidFill>
              <a:latin typeface="Gadget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0000"/>
                </a:solidFill>
                <a:latin typeface="Times New Roman"/>
                <a:ea typeface="ＭＳ Ｐゴシック"/>
              </a:rPr>
              <a:t>15.Giv’at-Koah</a:t>
            </a:r>
            <a:endParaRPr b="0" lang="en-US" sz="24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8" name="AutoShape 10"/>
          <p:cNvSpPr/>
          <p:nvPr/>
        </p:nvSpPr>
        <p:spPr>
          <a:xfrm>
            <a:off x="6572160" y="174600"/>
            <a:ext cx="120600" cy="2046240"/>
          </a:xfrm>
          <a:custGeom>
            <a:avLst/>
            <a:gdLst>
              <a:gd name="textAreaLeft" fmla="*/ 0 w 120600"/>
              <a:gd name="textAreaRight" fmla="*/ 43560 w 120600"/>
              <a:gd name="textAreaTop" fmla="*/ 33120 h 2046240"/>
              <a:gd name="textAreaBottom" fmla="*/ 2013120 h 20462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561"/>
                  <a:pt x="10800" y="1121"/>
                </a:cubicBezTo>
                <a:lnTo>
                  <a:pt x="10800" y="9679"/>
                </a:lnTo>
                <a:cubicBezTo>
                  <a:pt x="10800" y="10240"/>
                  <a:pt x="16200" y="10800"/>
                  <a:pt x="21600" y="10800"/>
                </a:cubicBezTo>
                <a:cubicBezTo>
                  <a:pt x="16200" y="10800"/>
                  <a:pt x="10800" y="11361"/>
                  <a:pt x="10800" y="11921"/>
                </a:cubicBezTo>
                <a:lnTo>
                  <a:pt x="10800" y="20479"/>
                </a:lnTo>
                <a:cubicBezTo>
                  <a:pt x="10800" y="2104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9" name="AutoShape 11"/>
          <p:cNvSpPr/>
          <p:nvPr/>
        </p:nvSpPr>
        <p:spPr>
          <a:xfrm>
            <a:off x="6581880" y="2370240"/>
            <a:ext cx="133200" cy="1646280"/>
          </a:xfrm>
          <a:custGeom>
            <a:avLst/>
            <a:gdLst>
              <a:gd name="textAreaLeft" fmla="*/ 0 w 133200"/>
              <a:gd name="textAreaRight" fmla="*/ 47880 w 133200"/>
              <a:gd name="textAreaTop" fmla="*/ 42120 h 1646280"/>
              <a:gd name="textAreaBottom" fmla="*/ 1604160 h 16462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884"/>
                  <a:pt x="10800" y="1767"/>
                </a:cubicBezTo>
                <a:lnTo>
                  <a:pt x="10800" y="9033"/>
                </a:lnTo>
                <a:cubicBezTo>
                  <a:pt x="10800" y="9917"/>
                  <a:pt x="16200" y="10800"/>
                  <a:pt x="21600" y="10800"/>
                </a:cubicBezTo>
                <a:cubicBezTo>
                  <a:pt x="16200" y="10800"/>
                  <a:pt x="10800" y="11684"/>
                  <a:pt x="10800" y="12567"/>
                </a:cubicBezTo>
                <a:lnTo>
                  <a:pt x="10800" y="19833"/>
                </a:lnTo>
                <a:cubicBezTo>
                  <a:pt x="10800" y="20717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0" name="AutoShape 12"/>
          <p:cNvSpPr/>
          <p:nvPr/>
        </p:nvSpPr>
        <p:spPr>
          <a:xfrm>
            <a:off x="6581880" y="4200480"/>
            <a:ext cx="158760" cy="1258920"/>
          </a:xfrm>
          <a:custGeom>
            <a:avLst/>
            <a:gdLst>
              <a:gd name="textAreaLeft" fmla="*/ 0 w 158760"/>
              <a:gd name="textAreaRight" fmla="*/ 57240 w 158760"/>
              <a:gd name="textAreaTop" fmla="*/ 32760 h 1258920"/>
              <a:gd name="textAreaBottom" fmla="*/ 1226160 h 1258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pic>
        <p:nvPicPr>
          <p:cNvPr id="51" name="Picture 34" descr=""/>
          <p:cNvPicPr/>
          <p:nvPr/>
        </p:nvPicPr>
        <p:blipFill>
          <a:blip r:embed="rId1"/>
          <a:stretch/>
        </p:blipFill>
        <p:spPr>
          <a:xfrm>
            <a:off x="378000" y="0"/>
            <a:ext cx="4095720" cy="5562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288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owner</dc:creator>
  <dc:description/>
  <dc:language>en-US</dc:language>
  <cp:lastModifiedBy>Owner</cp:lastModifiedBy>
  <cp:lastPrinted>2004-09-21T16:52:00Z</cp:lastPrinted>
  <dcterms:modified xsi:type="dcterms:W3CDTF">2011-09-22T07:10:45Z</dcterms:modified>
  <cp:revision>779</cp:revision>
  <dc:subject/>
  <dc:title>PowerPoint プレゼンテーション</dc:title>
</cp:coreProperties>
</file>